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9144000" cy="6858000" type="screen4x3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M Barnett" initials="MB" lastIdx="4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1912" autoAdjust="0"/>
  </p:normalViewPr>
  <p:slideViewPr>
    <p:cSldViewPr snapToGrid="0">
      <p:cViewPr varScale="1">
        <p:scale>
          <a:sx n="87" d="100"/>
          <a:sy n="87" d="100"/>
        </p:scale>
        <p:origin x="264" y="4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1800000" cy="1800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9AAEE0B-61C3-45DD-89B1-9BCB18057019}" type="datetimeFigureOut">
              <a:rPr kumimoji="1" lang="ja-JP" altLang="en-US" smtClean="0"/>
              <a:t>2016/12/23</a:t>
            </a:fld>
            <a:endParaRPr kumimoji="1" lang="ja-JP" altLang="en-US" dirty="0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66813" y="1241425"/>
            <a:ext cx="44640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 dirty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6EF62A6-A760-4D21-9A0A-31AE98FBD6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6706325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6EF62A6-A760-4D21-9A0A-31AE98FBD6F4}" type="slidenum">
              <a:rPr kumimoji="1" lang="ja-JP" altLang="en-US" smtClean="0"/>
              <a:t>1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96070395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0C85D-63BD-4BCD-A833-F79403F4A54D}" type="datetimeFigureOut">
              <a:rPr kumimoji="1" lang="ja-JP" altLang="en-US" smtClean="0"/>
              <a:t>2016/12/23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BD2C9-9379-4A63-8F24-1593180AE756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5996431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0C85D-63BD-4BCD-A833-F79403F4A54D}" type="datetimeFigureOut">
              <a:rPr kumimoji="1" lang="ja-JP" altLang="en-US" smtClean="0"/>
              <a:t>2016/12/23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BD2C9-9379-4A63-8F24-1593180AE756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232660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0C85D-63BD-4BCD-A833-F79403F4A54D}" type="datetimeFigureOut">
              <a:rPr kumimoji="1" lang="ja-JP" altLang="en-US" smtClean="0"/>
              <a:t>2016/12/23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BD2C9-9379-4A63-8F24-1593180AE756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2326555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0C85D-63BD-4BCD-A833-F79403F4A54D}" type="datetimeFigureOut">
              <a:rPr kumimoji="1" lang="ja-JP" altLang="en-US" smtClean="0"/>
              <a:t>2016/12/23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BD2C9-9379-4A63-8F24-1593180AE756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7014513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0C85D-63BD-4BCD-A833-F79403F4A54D}" type="datetimeFigureOut">
              <a:rPr kumimoji="1" lang="ja-JP" altLang="en-US" smtClean="0"/>
              <a:t>2016/12/23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BD2C9-9379-4A63-8F24-1593180AE756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46822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0C85D-63BD-4BCD-A833-F79403F4A54D}" type="datetimeFigureOut">
              <a:rPr kumimoji="1" lang="ja-JP" altLang="en-US" smtClean="0"/>
              <a:t>2016/12/23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BD2C9-9379-4A63-8F24-1593180AE756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6443266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0C85D-63BD-4BCD-A833-F79403F4A54D}" type="datetimeFigureOut">
              <a:rPr kumimoji="1" lang="ja-JP" altLang="en-US" smtClean="0"/>
              <a:t>2016/12/23</a:t>
            </a:fld>
            <a:endParaRPr kumimoji="1" lang="ja-JP" alt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BD2C9-9379-4A63-8F24-1593180AE756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1002805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0C85D-63BD-4BCD-A833-F79403F4A54D}" type="datetimeFigureOut">
              <a:rPr kumimoji="1" lang="ja-JP" altLang="en-US" smtClean="0"/>
              <a:t>2016/12/23</a:t>
            </a:fld>
            <a:endParaRPr kumimoji="1" lang="ja-JP" alt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BD2C9-9379-4A63-8F24-1593180AE756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0189249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0C85D-63BD-4BCD-A833-F79403F4A54D}" type="datetimeFigureOut">
              <a:rPr kumimoji="1" lang="ja-JP" altLang="en-US" smtClean="0"/>
              <a:t>2016/12/23</a:t>
            </a:fld>
            <a:endParaRPr kumimoji="1" lang="ja-JP" alt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BD2C9-9379-4A63-8F24-1593180AE756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5459348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0C85D-63BD-4BCD-A833-F79403F4A54D}" type="datetimeFigureOut">
              <a:rPr kumimoji="1" lang="ja-JP" altLang="en-US" smtClean="0"/>
              <a:t>2016/12/23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BD2C9-9379-4A63-8F24-1593180AE756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1351199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dirty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0C85D-63BD-4BCD-A833-F79403F4A54D}" type="datetimeFigureOut">
              <a:rPr kumimoji="1" lang="ja-JP" altLang="en-US" smtClean="0"/>
              <a:t>2016/12/23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BD2C9-9379-4A63-8F24-1593180AE756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5707508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B0C85D-63BD-4BCD-A833-F79403F4A54D}" type="datetimeFigureOut">
              <a:rPr kumimoji="1" lang="ja-JP" altLang="en-US" smtClean="0"/>
              <a:t>2016/12/23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ABD2C9-9379-4A63-8F24-1593180AE756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696360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4892949"/>
            <a:ext cx="9144000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ja-JP" alt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3</a:t>
            </a:r>
            <a:r>
              <a:rPr lang="ja-JP" alt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inical laboratory data at post-operative day (POD) 1 and POD7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kaline phosphatase (ALP)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ctate dehydrogenase (LDH) values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 POD7 are significantly higher than POD1 (ALP (median): 185 IU/L vs 208 IU/L, LDH (median): 200 IU/L vs 214 IU/L, respectively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bottom and top of the box show the 25 and 75% rankings and therefore the interquartile range. The minimum and maximum rankings are denoted by the lower and upper whiskers. Outliers are denoted by circles. Two groups were compared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y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lcoxon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gned-rank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est.</a:t>
            </a:r>
            <a:endParaRPr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2" name="グループ化 11"/>
          <p:cNvGrpSpPr/>
          <p:nvPr/>
        </p:nvGrpSpPr>
        <p:grpSpPr>
          <a:xfrm>
            <a:off x="4369326" y="57180"/>
            <a:ext cx="4465841" cy="4747175"/>
            <a:chOff x="57821" y="57180"/>
            <a:chExt cx="4465841" cy="4747175"/>
          </a:xfrm>
        </p:grpSpPr>
        <p:graphicFrame>
          <p:nvGraphicFramePr>
            <p:cNvPr id="11" name="オブジェクト 10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904954734"/>
                </p:ext>
              </p:extLst>
            </p:nvPr>
          </p:nvGraphicFramePr>
          <p:xfrm>
            <a:off x="694612" y="599082"/>
            <a:ext cx="3829050" cy="40163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63" name="Prism 6" r:id="rId4" imgW="3829683" imgH="4016078" progId="Prism6.Document">
                    <p:embed/>
                  </p:oleObj>
                </mc:Choice>
                <mc:Fallback>
                  <p:oleObj name="Prism 6" r:id="rId4" imgW="3829683" imgH="4016078" progId="Prism6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694612" y="599082"/>
                          <a:ext cx="3829050" cy="40163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" name="テキスト ボックス 4"/>
            <p:cNvSpPr txBox="1"/>
            <p:nvPr/>
          </p:nvSpPr>
          <p:spPr>
            <a:xfrm>
              <a:off x="142225" y="681363"/>
              <a:ext cx="680484" cy="338554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16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0</a:t>
              </a:r>
              <a:endParaRPr kumimoji="1"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テキスト ボックス 5"/>
            <p:cNvSpPr txBox="1"/>
            <p:nvPr/>
          </p:nvSpPr>
          <p:spPr>
            <a:xfrm>
              <a:off x="142225" y="1399725"/>
              <a:ext cx="680484" cy="338554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16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kumimoji="1"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テキスト ボックス 6"/>
            <p:cNvSpPr txBox="1"/>
            <p:nvPr/>
          </p:nvSpPr>
          <p:spPr>
            <a:xfrm>
              <a:off x="142225" y="2118087"/>
              <a:ext cx="680484" cy="338554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16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0</a:t>
              </a:r>
              <a:endParaRPr kumimoji="1"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テキスト ボックス 7"/>
            <p:cNvSpPr txBox="1"/>
            <p:nvPr/>
          </p:nvSpPr>
          <p:spPr>
            <a:xfrm>
              <a:off x="142225" y="2836449"/>
              <a:ext cx="680484" cy="338554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16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kumimoji="1"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142225" y="3554811"/>
              <a:ext cx="680484" cy="338554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16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1"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テキスト ボックス 9"/>
            <p:cNvSpPr txBox="1"/>
            <p:nvPr/>
          </p:nvSpPr>
          <p:spPr>
            <a:xfrm>
              <a:off x="142225" y="4273173"/>
              <a:ext cx="680484" cy="338554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16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テキスト ボックス 20"/>
            <p:cNvSpPr txBox="1"/>
            <p:nvPr/>
          </p:nvSpPr>
          <p:spPr>
            <a:xfrm>
              <a:off x="958319" y="4465801"/>
              <a:ext cx="1535983" cy="338554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ja-JP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OD1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テキスト ボックス 21"/>
            <p:cNvSpPr txBox="1"/>
            <p:nvPr/>
          </p:nvSpPr>
          <p:spPr>
            <a:xfrm rot="16200000">
              <a:off x="-540894" y="2499857"/>
              <a:ext cx="1535983" cy="338554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ja-JP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DH (IU/L)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" name="テキスト ボックス 1"/>
            <p:cNvSpPr txBox="1"/>
            <p:nvPr/>
          </p:nvSpPr>
          <p:spPr>
            <a:xfrm>
              <a:off x="872754" y="57180"/>
              <a:ext cx="3571201" cy="40011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kumimoji="1" lang="en-US" altLang="ja-JP" sz="2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DH</a:t>
              </a:r>
              <a:endParaRPr kumimoji="1"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テキスト ボックス 42"/>
            <p:cNvSpPr txBox="1"/>
            <p:nvPr/>
          </p:nvSpPr>
          <p:spPr>
            <a:xfrm>
              <a:off x="2753450" y="4465187"/>
              <a:ext cx="1535983" cy="338554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ja-JP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OD7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6" name="直線コネクタ 15"/>
            <p:cNvCxnSpPr/>
            <p:nvPr/>
          </p:nvCxnSpPr>
          <p:spPr>
            <a:xfrm>
              <a:off x="1733703" y="782734"/>
              <a:ext cx="0" cy="67405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線コネクタ 33"/>
            <p:cNvCxnSpPr/>
            <p:nvPr/>
          </p:nvCxnSpPr>
          <p:spPr>
            <a:xfrm>
              <a:off x="3524708" y="782734"/>
              <a:ext cx="0" cy="168249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線コネクタ 35"/>
            <p:cNvCxnSpPr/>
            <p:nvPr/>
          </p:nvCxnSpPr>
          <p:spPr>
            <a:xfrm flipH="1">
              <a:off x="1726388" y="782040"/>
              <a:ext cx="17983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テキスト ボックス 38"/>
            <p:cNvSpPr txBox="1"/>
            <p:nvPr/>
          </p:nvSpPr>
          <p:spPr>
            <a:xfrm>
              <a:off x="1910887" y="430469"/>
              <a:ext cx="1535983" cy="338554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ja-JP" sz="16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altLang="ja-JP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&lt; 0.001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3" name="グループ化 12"/>
          <p:cNvGrpSpPr/>
          <p:nvPr/>
        </p:nvGrpSpPr>
        <p:grpSpPr>
          <a:xfrm>
            <a:off x="0" y="56566"/>
            <a:ext cx="4477227" cy="4747175"/>
            <a:chOff x="4357940" y="56566"/>
            <a:chExt cx="4477227" cy="4747175"/>
          </a:xfrm>
        </p:grpSpPr>
        <p:graphicFrame>
          <p:nvGraphicFramePr>
            <p:cNvPr id="3" name="オブジェクト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65556526"/>
                </p:ext>
              </p:extLst>
            </p:nvPr>
          </p:nvGraphicFramePr>
          <p:xfrm>
            <a:off x="5006117" y="599082"/>
            <a:ext cx="3829050" cy="39703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64" name="Prism 6" r:id="rId6" imgW="3829683" imgH="3970338" progId="Prism6.Document">
                    <p:embed/>
                  </p:oleObj>
                </mc:Choice>
                <mc:Fallback>
                  <p:oleObj name="Prism 6" r:id="rId6" imgW="3829683" imgH="3970338" progId="Prism6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5006117" y="599082"/>
                          <a:ext cx="3829050" cy="39703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4" name="テキスト ボックス 43"/>
            <p:cNvSpPr txBox="1"/>
            <p:nvPr/>
          </p:nvSpPr>
          <p:spPr>
            <a:xfrm>
              <a:off x="4442344" y="680749"/>
              <a:ext cx="680484" cy="338554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r>
                <a:rPr lang="en-US" altLang="ja-JP" sz="16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0</a:t>
              </a:r>
              <a:endParaRPr kumimoji="1"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テキスト ボックス 45"/>
            <p:cNvSpPr txBox="1"/>
            <p:nvPr/>
          </p:nvSpPr>
          <p:spPr>
            <a:xfrm>
              <a:off x="4442344" y="1578701"/>
              <a:ext cx="680484" cy="338554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r>
                <a:rPr lang="en-US" altLang="ja-JP" sz="16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0</a:t>
              </a:r>
              <a:endParaRPr kumimoji="1"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テキスト ボックス 46"/>
            <p:cNvSpPr txBox="1"/>
            <p:nvPr/>
          </p:nvSpPr>
          <p:spPr>
            <a:xfrm>
              <a:off x="4442344" y="2476653"/>
              <a:ext cx="680484" cy="338554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r>
                <a:rPr lang="en-US" altLang="ja-JP" sz="16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0</a:t>
              </a:r>
              <a:endParaRPr kumimoji="1"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テキスト ボックス 47"/>
            <p:cNvSpPr txBox="1"/>
            <p:nvPr/>
          </p:nvSpPr>
          <p:spPr>
            <a:xfrm>
              <a:off x="4442344" y="3374605"/>
              <a:ext cx="680484" cy="338554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altLang="ja-JP" sz="16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0</a:t>
              </a:r>
              <a:endParaRPr kumimoji="1"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テキスト ボックス 48"/>
            <p:cNvSpPr txBox="1"/>
            <p:nvPr/>
          </p:nvSpPr>
          <p:spPr>
            <a:xfrm>
              <a:off x="4442344" y="4272559"/>
              <a:ext cx="680484" cy="338554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16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テキスト ボックス 49"/>
            <p:cNvSpPr txBox="1"/>
            <p:nvPr/>
          </p:nvSpPr>
          <p:spPr>
            <a:xfrm>
              <a:off x="5258438" y="4465187"/>
              <a:ext cx="1535983" cy="338554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ja-JP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OD1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テキスト ボックス 50"/>
            <p:cNvSpPr txBox="1"/>
            <p:nvPr/>
          </p:nvSpPr>
          <p:spPr>
            <a:xfrm rot="16200000">
              <a:off x="3759225" y="2499243"/>
              <a:ext cx="1535983" cy="338554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ja-JP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LP (IU/L)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テキスト ボックス 51"/>
            <p:cNvSpPr txBox="1"/>
            <p:nvPr/>
          </p:nvSpPr>
          <p:spPr>
            <a:xfrm>
              <a:off x="5172873" y="56566"/>
              <a:ext cx="3571201" cy="40011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ja-JP" sz="2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LP</a:t>
              </a:r>
              <a:endParaRPr kumimoji="1"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テキスト ボックス 53"/>
            <p:cNvSpPr txBox="1"/>
            <p:nvPr/>
          </p:nvSpPr>
          <p:spPr>
            <a:xfrm>
              <a:off x="7053569" y="4464573"/>
              <a:ext cx="1535983" cy="338554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ja-JP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OD7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0" name="直線コネクタ 39"/>
            <p:cNvCxnSpPr/>
            <p:nvPr/>
          </p:nvCxnSpPr>
          <p:spPr>
            <a:xfrm>
              <a:off x="6047778" y="1136190"/>
              <a:ext cx="0" cy="14021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線コネクタ 40"/>
            <p:cNvCxnSpPr/>
            <p:nvPr/>
          </p:nvCxnSpPr>
          <p:spPr>
            <a:xfrm>
              <a:off x="7838783" y="1136190"/>
              <a:ext cx="0" cy="168249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直線コネクタ 41"/>
            <p:cNvCxnSpPr/>
            <p:nvPr/>
          </p:nvCxnSpPr>
          <p:spPr>
            <a:xfrm flipH="1">
              <a:off x="6040463" y="1135496"/>
              <a:ext cx="17983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テキスト ボックス 44"/>
            <p:cNvSpPr txBox="1"/>
            <p:nvPr/>
          </p:nvSpPr>
          <p:spPr>
            <a:xfrm>
              <a:off x="6224962" y="783925"/>
              <a:ext cx="1535983" cy="338554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ja-JP" sz="16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altLang="ja-JP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&lt; 0.001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087882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88</TotalTime>
  <Words>35</Words>
  <Application>Microsoft Office PowerPoint</Application>
  <PresentationFormat>画面に合わせる (4:3)</PresentationFormat>
  <Paragraphs>23</Paragraphs>
  <Slides>1</Slides>
  <Notes>1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ＭＳ Ｐゴシック</vt:lpstr>
      <vt:lpstr>Arial</vt:lpstr>
      <vt:lpstr>Calibri</vt:lpstr>
      <vt:lpstr>Calibri Light</vt:lpstr>
      <vt:lpstr>Times New Roman</vt:lpstr>
      <vt:lpstr>Office テーマ</vt:lpstr>
      <vt:lpstr>Prism 6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近藤悠希【Yuki KONDO】</dc:creator>
  <cp:lastModifiedBy>近藤悠希【Yuki KONDO】</cp:lastModifiedBy>
  <cp:revision>47</cp:revision>
  <cp:lastPrinted>2016-08-08T11:36:20Z</cp:lastPrinted>
  <dcterms:created xsi:type="dcterms:W3CDTF">2016-06-10T02:56:22Z</dcterms:created>
  <dcterms:modified xsi:type="dcterms:W3CDTF">2016-12-23T10:57:22Z</dcterms:modified>
</cp:coreProperties>
</file>